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37817-7FF8-4AAB-AEC3-96B8E29163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A3B363-4CC6-430E-BC63-5752D5D546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352C7-F4A9-4D22-AF1E-F6D313DFDD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246855-7A35-4336-AED0-F535717DB8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6669F-B76B-4354-8DFC-0479FFB9F7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6AAB84-C9F9-41FD-8A45-B29E03B509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B250C5-02F3-438B-8E76-4A9EA657CE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CA292-BE8E-475D-8A15-FF973342E7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F135CC-F540-483F-B43D-B90EDED87E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B4D459-8F3B-4C33-A2FC-ECCF12C7D6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446EC7-1272-4E41-BFD0-89B5AF4512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AE683-A890-4C28-994A-9B6EE109B0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362AA1-AFED-4822-89AC-4FD839CE06BB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708360" y="2455920"/>
          <a:ext cx="1584360" cy="666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708360" y="2455920"/>
                    <a:ext cx="1584360" cy="6667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3708360" y="3176640"/>
          <a:ext cx="1584360" cy="5763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708360" y="3176640"/>
                    <a:ext cx="1584360" cy="576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5292360" y="2643120"/>
            <a:ext cx="49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292000" y="329256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3639240" y="194616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V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4132440" y="188172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N-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4564080" y="1811160"/>
            <a:ext cx="101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-VACO4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710160" y="1413000"/>
            <a:ext cx="158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141800" y="112536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CT1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896840" y="4508640"/>
            <a:ext cx="55011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Figure S2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iton-X100 cell lysates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from HCT116 cells express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either the sh-VEC, the sh-N-APC or the shVACO4A were submitted to wester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lotting using either anti-APC or anti-</a:t>
            </a:r>
            <a:r>
              <a:rPr b="0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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actin antibodi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2200" y="43560"/>
            <a:ext cx="164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Vijaya Chandra et al.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4T12:41:56Z</dcterms:created>
  <dc:creator>jschneik</dc:creator>
  <dc:description/>
  <dc:language>en-US</dc:language>
  <cp:lastModifiedBy>jschneik</cp:lastModifiedBy>
  <dcterms:modified xsi:type="dcterms:W3CDTF">2012-03-12T10:27:30Z</dcterms:modified>
  <cp:revision>47</cp:revision>
  <dc:subject/>
  <dc:title>Folie 1</dc:title>
</cp:coreProperties>
</file>